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0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84" autoAdjust="0"/>
    <p:restoredTop sz="94626"/>
  </p:normalViewPr>
  <p:slideViewPr>
    <p:cSldViewPr snapToGrid="0">
      <p:cViewPr varScale="1">
        <p:scale>
          <a:sx n="121" d="100"/>
          <a:sy n="121" d="100"/>
        </p:scale>
        <p:origin x="784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35FAEB7-B30D-EE46-B443-4FCE0CD3A652}" type="datetimeFigureOut">
              <a:rPr lang="en-US" smtClean="0"/>
              <a:t>11/2/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D6A1FE-1F75-4D40-A962-0382E2FEC6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675031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E594FB8-7EBF-5750-0546-84921E35501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A5C075A-FBC4-1E23-1EB3-2752DC517F4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FC09207-E216-E47F-2F19-31C871F02D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844792-A92B-48E8-9A01-BE94945EB46F}" type="datetimeFigureOut">
              <a:rPr lang="en-IN" smtClean="0"/>
              <a:t>02/11/25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AB5065F-FE15-96CD-FF0E-6797067F24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1125AAC-DDD4-8AF4-CA2F-B48F37C596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392BD5-315B-4FD3-A085-11D6CCCEAB5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0186741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E1DBAA4-1810-7742-D542-6458A8786E1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42D8A04-05D5-D590-1227-C0B22E2419C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2E3BFD2-91D8-13F8-B338-54290E3A69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844792-A92B-48E8-9A01-BE94945EB46F}" type="datetimeFigureOut">
              <a:rPr lang="en-IN" smtClean="0"/>
              <a:t>02/11/25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06259CB-5996-4F7F-7382-C7D87188C8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8266614-3620-F682-08CF-0B9B190984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392BD5-315B-4FD3-A085-11D6CCCEAB5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6176442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CEC2800-3F93-ED8F-65F5-A8D1BF7EC76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743222F-8044-21DC-3181-823F1F3AC3B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A6B11D2-6759-9B91-F29A-E83315146F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844792-A92B-48E8-9A01-BE94945EB46F}" type="datetimeFigureOut">
              <a:rPr lang="en-IN" smtClean="0"/>
              <a:t>02/11/25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7A100AD-CEC0-BE7D-F1E4-A1E28A0E6E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D2E7C33-B4EA-D96C-6B0A-C114BD4D02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392BD5-315B-4FD3-A085-11D6CCCEAB5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2523390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F173A49-8495-9D24-C5CF-79EB5868797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3A3155F-DDDF-3DC7-2C09-2AF354EF4F5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BC317E9-E497-942E-0754-A82BCB8C02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844792-A92B-48E8-9A01-BE94945EB46F}" type="datetimeFigureOut">
              <a:rPr lang="en-IN" smtClean="0"/>
              <a:t>02/11/25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37DDB49-39D0-ECC1-5844-8DCABB1464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7AD7598-A414-D214-64C7-BB084C928E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392BD5-315B-4FD3-A085-11D6CCCEAB5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98140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E5F8A85-4F65-824D-ECA7-10EF3ED9379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6A3B8D2-4659-1393-9BDB-7C29BE3DCF3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C70BFD8-CC5B-6475-C0EF-C4A526E5D0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844792-A92B-48E8-9A01-BE94945EB46F}" type="datetimeFigureOut">
              <a:rPr lang="en-IN" smtClean="0"/>
              <a:t>02/11/25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FF850CE-28CE-FE77-203E-229103D340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5DC052B-CA79-5FC7-34D6-C837FB4EC1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392BD5-315B-4FD3-A085-11D6CCCEAB5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0222119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21588E1-5A67-CA61-DB9C-CEB618C9210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DB72387-82F9-93EA-A85D-39BB8876356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31AD5EB-3F18-9F23-667A-37AB749D8D6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4E55A2C-5141-CBED-5E42-FCCAE74849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844792-A92B-48E8-9A01-BE94945EB46F}" type="datetimeFigureOut">
              <a:rPr lang="en-IN" smtClean="0"/>
              <a:t>02/11/25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C4A315F-99D7-39A5-E26D-7E1551ADC5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0671582-FDEA-B2F7-61FB-AC0D91DFB4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392BD5-315B-4FD3-A085-11D6CCCEAB5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6738164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4E8BF30-D2F3-5252-A6E5-9DD78FAB070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1D0B92F-6579-86F5-FA89-BBFD4BB17E5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9B787B0-1A76-8D45-5B72-C5223B0E902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2213D76-4328-1636-128F-F59E54CE003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D8A8D77-4576-B339-51F3-931231B89CA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98CF7B3-D52C-15D9-4C3C-7C3879C004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844792-A92B-48E8-9A01-BE94945EB46F}" type="datetimeFigureOut">
              <a:rPr lang="en-IN" smtClean="0"/>
              <a:t>02/11/25</a:t>
            </a:fld>
            <a:endParaRPr lang="en-IN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3975B61-1514-CE3F-B65D-436D279147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4D6B971-173D-F298-C2B3-8498DB4716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392BD5-315B-4FD3-A085-11D6CCCEAB5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5232487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AE96902-8E8A-CBE2-96DD-B29E6379841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E8B398C-774A-D96D-94A7-D645329BE1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844792-A92B-48E8-9A01-BE94945EB46F}" type="datetimeFigureOut">
              <a:rPr lang="en-IN" smtClean="0"/>
              <a:t>02/11/25</a:t>
            </a:fld>
            <a:endParaRPr lang="en-IN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634037B-EE55-5938-4901-F783AA0384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A38CAFC-4C55-09CC-C662-88A59BD296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392BD5-315B-4FD3-A085-11D6CCCEAB5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5302264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3E2ABE7-0C5E-09F8-323E-E95C1E5B1A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844792-A92B-48E8-9A01-BE94945EB46F}" type="datetimeFigureOut">
              <a:rPr lang="en-IN" smtClean="0"/>
              <a:t>02/11/25</a:t>
            </a:fld>
            <a:endParaRPr lang="en-IN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B672863-BBD4-C563-8146-9D2326D846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523FA2A-586B-DB36-8E45-F03F131F5E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392BD5-315B-4FD3-A085-11D6CCCEAB5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1214224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368D423-23D3-D3F3-C691-8894583AA2D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7A7F08E-4F11-8B64-8350-6786F9D2F71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6EAFF54-B689-8C21-CE9E-A7C860FE7EC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B157115-3B5E-32DC-EE65-CFBEA3D594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844792-A92B-48E8-9A01-BE94945EB46F}" type="datetimeFigureOut">
              <a:rPr lang="en-IN" smtClean="0"/>
              <a:t>02/11/25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674FFAC-BA7E-4AC0-B8F8-3ED6EC3D75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629E302-A481-000E-28D3-09741827F1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392BD5-315B-4FD3-A085-11D6CCCEAB5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1182103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41A84CF-E05A-D73E-36F8-3BB6D2DA88B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7DABA35-33ED-61E2-9B14-37768AF1610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34E4341-DBC6-92EF-D548-92C76C898EA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1D118D6-A123-40AE-FDAF-2DB4EF2AF7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844792-A92B-48E8-9A01-BE94945EB46F}" type="datetimeFigureOut">
              <a:rPr lang="en-IN" smtClean="0"/>
              <a:t>02/11/25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043EE96-8736-CE26-7F03-2B0D1C6B57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048BC1B-A827-6730-9941-84E9FBA3EC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392BD5-315B-4FD3-A085-11D6CCCEAB5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7477676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3FE6730-B1DC-9FDA-71EC-1EB89CF577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D56A655-F126-4F35-3C49-43195543D89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EBC2D65-0B1D-8880-00B0-57B8DE10631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6844792-A92B-48E8-9A01-BE94945EB46F}" type="datetimeFigureOut">
              <a:rPr lang="en-IN" smtClean="0"/>
              <a:t>02/11/25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B36F498-8CBD-343A-2E5C-51CDC9C95E8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EDE6A55-F901-E065-EB6E-C1CA8A4CD59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0392BD5-315B-4FD3-A085-11D6CCCEAB5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955452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27" name="Rectangle 26">
            <a:extLst>
              <a:ext uri="{FF2B5EF4-FFF2-40B4-BE49-F238E27FC236}">
                <a16:creationId xmlns:a16="http://schemas.microsoft.com/office/drawing/2014/main" id="{C7336F7B-7038-4227-BCAC-E417CC3F669D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-1"/>
            <a:ext cx="12188952" cy="68580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80F969D5-A51E-409A-5A90-06A8D065921F}"/>
              </a:ext>
            </a:extLst>
          </p:cNvPr>
          <p:cNvGrpSpPr/>
          <p:nvPr/>
        </p:nvGrpSpPr>
        <p:grpSpPr>
          <a:xfrm>
            <a:off x="1529294" y="957454"/>
            <a:ext cx="8237654" cy="367601"/>
            <a:chOff x="1550827" y="733457"/>
            <a:chExt cx="8237654" cy="367601"/>
          </a:xfrm>
        </p:grpSpPr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2FB924EB-48DA-153B-93E6-885502669943}"/>
                </a:ext>
              </a:extLst>
            </p:cNvPr>
            <p:cNvSpPr txBox="1"/>
            <p:nvPr/>
          </p:nvSpPr>
          <p:spPr>
            <a:xfrm>
              <a:off x="1550827" y="757846"/>
              <a:ext cx="52290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400" b="1" dirty="0"/>
                <a:t>H2A</a:t>
              </a: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7CB0DBC5-E460-A616-833C-FB45212C980A}"/>
                </a:ext>
              </a:extLst>
            </p:cNvPr>
            <p:cNvSpPr txBox="1"/>
            <p:nvPr/>
          </p:nvSpPr>
          <p:spPr>
            <a:xfrm>
              <a:off x="5249560" y="793281"/>
              <a:ext cx="52290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400" b="1" dirty="0"/>
                <a:t>H2B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0244193F-D827-38E9-DF41-AC7CB5012A4D}"/>
                </a:ext>
              </a:extLst>
            </p:cNvPr>
            <p:cNvSpPr txBox="1"/>
            <p:nvPr/>
          </p:nvSpPr>
          <p:spPr>
            <a:xfrm>
              <a:off x="9376189" y="733457"/>
              <a:ext cx="41229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400" b="1" dirty="0"/>
                <a:t>H3</a:t>
              </a:r>
            </a:p>
          </p:txBody>
        </p:sp>
      </p:grpSp>
      <p:grpSp>
        <p:nvGrpSpPr>
          <p:cNvPr id="7" name="Group 6">
            <a:extLst>
              <a:ext uri="{FF2B5EF4-FFF2-40B4-BE49-F238E27FC236}">
                <a16:creationId xmlns:a16="http://schemas.microsoft.com/office/drawing/2014/main" id="{88AA1238-0119-7B0D-0FC4-068584BA13CD}"/>
              </a:ext>
            </a:extLst>
          </p:cNvPr>
          <p:cNvGrpSpPr/>
          <p:nvPr/>
        </p:nvGrpSpPr>
        <p:grpSpPr>
          <a:xfrm>
            <a:off x="1770821" y="3809184"/>
            <a:ext cx="8238066" cy="345202"/>
            <a:chOff x="1979903" y="6088574"/>
            <a:chExt cx="8238066" cy="345202"/>
          </a:xfrm>
        </p:grpSpPr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F1792E80-30DB-F64C-BA23-3488D1BF4D5E}"/>
                </a:ext>
              </a:extLst>
            </p:cNvPr>
            <p:cNvSpPr txBox="1"/>
            <p:nvPr/>
          </p:nvSpPr>
          <p:spPr>
            <a:xfrm>
              <a:off x="1979903" y="6088574"/>
              <a:ext cx="41229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400" b="1" dirty="0"/>
                <a:t>H4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020D0292-5948-C23C-B371-0BEBD6A3DBF0}"/>
                </a:ext>
              </a:extLst>
            </p:cNvPr>
            <p:cNvSpPr txBox="1"/>
            <p:nvPr/>
          </p:nvSpPr>
          <p:spPr>
            <a:xfrm>
              <a:off x="5447861" y="6125999"/>
              <a:ext cx="70884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400" b="1" dirty="0"/>
                <a:t>H3/H4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1760EF86-430B-FE9F-1DCF-656F62323FF1}"/>
                </a:ext>
              </a:extLst>
            </p:cNvPr>
            <p:cNvSpPr txBox="1"/>
            <p:nvPr/>
          </p:nvSpPr>
          <p:spPr>
            <a:xfrm>
              <a:off x="9087916" y="6117273"/>
              <a:ext cx="113005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400" b="1" dirty="0"/>
                <a:t>MacroH2A1</a:t>
              </a:r>
            </a:p>
          </p:txBody>
        </p:sp>
      </p:grpSp>
      <p:sp>
        <p:nvSpPr>
          <p:cNvPr id="14" name="TextBox 13">
            <a:extLst>
              <a:ext uri="{FF2B5EF4-FFF2-40B4-BE49-F238E27FC236}">
                <a16:creationId xmlns:a16="http://schemas.microsoft.com/office/drawing/2014/main" id="{8055074C-C3A0-A242-27B6-BB76898B32AB}"/>
              </a:ext>
            </a:extLst>
          </p:cNvPr>
          <p:cNvSpPr txBox="1"/>
          <p:nvPr/>
        </p:nvSpPr>
        <p:spPr>
          <a:xfrm>
            <a:off x="1551516" y="3333283"/>
            <a:ext cx="63510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b="1" dirty="0"/>
              <a:t>AF Status</a:t>
            </a:r>
            <a:endParaRPr lang="en-US" b="1" dirty="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4844395C-F724-33B2-C6E7-69FF151D7DC5}"/>
              </a:ext>
            </a:extLst>
          </p:cNvPr>
          <p:cNvSpPr txBox="1"/>
          <p:nvPr/>
        </p:nvSpPr>
        <p:spPr>
          <a:xfrm>
            <a:off x="2356241" y="3325932"/>
            <a:ext cx="6543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Persistent</a:t>
            </a:r>
            <a:endParaRPr lang="en-US" dirty="0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63F5904C-989A-288B-21DE-94DBF72CFB53}"/>
              </a:ext>
            </a:extLst>
          </p:cNvPr>
          <p:cNvSpPr txBox="1"/>
          <p:nvPr/>
        </p:nvSpPr>
        <p:spPr>
          <a:xfrm>
            <a:off x="667824" y="3324169"/>
            <a:ext cx="53412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Control</a:t>
            </a:r>
            <a:endParaRPr lang="en-US" dirty="0"/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EEA9FBD0-32B1-DBBF-3F88-69E17218775C}"/>
              </a:ext>
            </a:extLst>
          </p:cNvPr>
          <p:cNvSpPr/>
          <p:nvPr/>
        </p:nvSpPr>
        <p:spPr>
          <a:xfrm>
            <a:off x="2705561" y="1048148"/>
            <a:ext cx="131348" cy="50824"/>
          </a:xfrm>
          <a:prstGeom prst="rect">
            <a:avLst/>
          </a:prstGeom>
          <a:solidFill>
            <a:schemeClr val="accent2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3263E7DD-570F-FFC6-1642-F83D63BACB71}"/>
              </a:ext>
            </a:extLst>
          </p:cNvPr>
          <p:cNvSpPr/>
          <p:nvPr/>
        </p:nvSpPr>
        <p:spPr>
          <a:xfrm>
            <a:off x="2705561" y="1184642"/>
            <a:ext cx="131348" cy="50824"/>
          </a:xfrm>
          <a:prstGeom prst="rect">
            <a:avLst/>
          </a:prstGeom>
          <a:solidFill>
            <a:srgbClr val="2DD4ED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rgbClr val="2DD4ED"/>
              </a:solidFill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6B047040-6216-5FBB-A273-B6C3DB46FEDA}"/>
              </a:ext>
            </a:extLst>
          </p:cNvPr>
          <p:cNvSpPr txBox="1"/>
          <p:nvPr/>
        </p:nvSpPr>
        <p:spPr>
          <a:xfrm>
            <a:off x="2806441" y="942538"/>
            <a:ext cx="39155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No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9D81DE32-C71E-DA56-183D-CF4E2D9083C0}"/>
              </a:ext>
            </a:extLst>
          </p:cNvPr>
          <p:cNvSpPr txBox="1"/>
          <p:nvPr/>
        </p:nvSpPr>
        <p:spPr>
          <a:xfrm>
            <a:off x="2806440" y="1098972"/>
            <a:ext cx="46706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Yes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ADCB6523-9E83-78B3-1F31-B5A24FB4DBFF}"/>
              </a:ext>
            </a:extLst>
          </p:cNvPr>
          <p:cNvSpPr txBox="1"/>
          <p:nvPr/>
        </p:nvSpPr>
        <p:spPr>
          <a:xfrm>
            <a:off x="5108561" y="3358284"/>
            <a:ext cx="63510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b="1" dirty="0"/>
              <a:t>AF Status</a:t>
            </a:r>
            <a:endParaRPr lang="en-US" b="1" dirty="0"/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298A27FF-A589-3442-E5C9-9ACB2ED33516}"/>
              </a:ext>
            </a:extLst>
          </p:cNvPr>
          <p:cNvSpPr txBox="1"/>
          <p:nvPr/>
        </p:nvSpPr>
        <p:spPr>
          <a:xfrm>
            <a:off x="5957629" y="3350538"/>
            <a:ext cx="6543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Persistent</a:t>
            </a:r>
            <a:endParaRPr lang="en-US" dirty="0"/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8FD591B3-3BC7-8743-B9BC-4A641C10D6CF}"/>
              </a:ext>
            </a:extLst>
          </p:cNvPr>
          <p:cNvSpPr txBox="1"/>
          <p:nvPr/>
        </p:nvSpPr>
        <p:spPr>
          <a:xfrm>
            <a:off x="4238696" y="3358156"/>
            <a:ext cx="53412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Control</a:t>
            </a:r>
            <a:endParaRPr lang="en-US" dirty="0"/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37B7A3DF-0A13-B767-6259-09BF933A5391}"/>
              </a:ext>
            </a:extLst>
          </p:cNvPr>
          <p:cNvSpPr/>
          <p:nvPr/>
        </p:nvSpPr>
        <p:spPr>
          <a:xfrm>
            <a:off x="6373894" y="992324"/>
            <a:ext cx="131348" cy="50824"/>
          </a:xfrm>
          <a:prstGeom prst="rect">
            <a:avLst/>
          </a:prstGeom>
          <a:solidFill>
            <a:schemeClr val="accent2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" name="Rectangle 31">
            <a:extLst>
              <a:ext uri="{FF2B5EF4-FFF2-40B4-BE49-F238E27FC236}">
                <a16:creationId xmlns:a16="http://schemas.microsoft.com/office/drawing/2014/main" id="{693D42F7-83A6-61CC-4521-45B95A4B33FF}"/>
              </a:ext>
            </a:extLst>
          </p:cNvPr>
          <p:cNvSpPr/>
          <p:nvPr/>
        </p:nvSpPr>
        <p:spPr>
          <a:xfrm>
            <a:off x="6373894" y="1128818"/>
            <a:ext cx="131348" cy="50824"/>
          </a:xfrm>
          <a:prstGeom prst="rect">
            <a:avLst/>
          </a:prstGeom>
          <a:solidFill>
            <a:srgbClr val="2DD4ED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rgbClr val="2DD4ED"/>
              </a:solidFill>
            </a:endParaRP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45B0BFB0-0A87-1630-A06E-9211C29498C9}"/>
              </a:ext>
            </a:extLst>
          </p:cNvPr>
          <p:cNvSpPr txBox="1"/>
          <p:nvPr/>
        </p:nvSpPr>
        <p:spPr>
          <a:xfrm>
            <a:off x="6474774" y="886714"/>
            <a:ext cx="39155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No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E39DA2F5-63A0-8FDA-69AD-018CB8302986}"/>
              </a:ext>
            </a:extLst>
          </p:cNvPr>
          <p:cNvSpPr txBox="1"/>
          <p:nvPr/>
        </p:nvSpPr>
        <p:spPr>
          <a:xfrm>
            <a:off x="6474773" y="1043148"/>
            <a:ext cx="46706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Yes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0AE67B36-A6BB-C6B0-F4CD-3A27C7FBD5D6}"/>
              </a:ext>
            </a:extLst>
          </p:cNvPr>
          <p:cNvSpPr txBox="1"/>
          <p:nvPr/>
        </p:nvSpPr>
        <p:spPr>
          <a:xfrm>
            <a:off x="9292361" y="3335441"/>
            <a:ext cx="63510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b="1" dirty="0"/>
              <a:t>AF Status</a:t>
            </a:r>
            <a:endParaRPr lang="en-US" b="1" dirty="0"/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A61BB9B4-28D5-A67B-BFF4-3722F6B84CED}"/>
              </a:ext>
            </a:extLst>
          </p:cNvPr>
          <p:cNvSpPr txBox="1"/>
          <p:nvPr/>
        </p:nvSpPr>
        <p:spPr>
          <a:xfrm>
            <a:off x="10048155" y="3325714"/>
            <a:ext cx="6543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Persistent</a:t>
            </a:r>
            <a:endParaRPr lang="en-US" dirty="0"/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9359DAC9-C529-6817-B961-5A524D8A119E}"/>
              </a:ext>
            </a:extLst>
          </p:cNvPr>
          <p:cNvSpPr txBox="1"/>
          <p:nvPr/>
        </p:nvSpPr>
        <p:spPr>
          <a:xfrm>
            <a:off x="8477392" y="3335441"/>
            <a:ext cx="53412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Control</a:t>
            </a:r>
            <a:endParaRPr lang="en-US" dirty="0"/>
          </a:p>
        </p:txBody>
      </p:sp>
      <p:sp>
        <p:nvSpPr>
          <p:cNvPr id="40" name="Rectangle 39">
            <a:extLst>
              <a:ext uri="{FF2B5EF4-FFF2-40B4-BE49-F238E27FC236}">
                <a16:creationId xmlns:a16="http://schemas.microsoft.com/office/drawing/2014/main" id="{0B8D4BF3-3FCD-4AE7-54F5-538B2B3F86C8}"/>
              </a:ext>
            </a:extLst>
          </p:cNvPr>
          <p:cNvSpPr/>
          <p:nvPr/>
        </p:nvSpPr>
        <p:spPr>
          <a:xfrm>
            <a:off x="10328295" y="1011898"/>
            <a:ext cx="131348" cy="50824"/>
          </a:xfrm>
          <a:prstGeom prst="rect">
            <a:avLst/>
          </a:prstGeom>
          <a:solidFill>
            <a:schemeClr val="accent2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1" name="Rectangle 40">
            <a:extLst>
              <a:ext uri="{FF2B5EF4-FFF2-40B4-BE49-F238E27FC236}">
                <a16:creationId xmlns:a16="http://schemas.microsoft.com/office/drawing/2014/main" id="{9051025C-2A02-6C10-E7BF-2066D81BDFF4}"/>
              </a:ext>
            </a:extLst>
          </p:cNvPr>
          <p:cNvSpPr/>
          <p:nvPr/>
        </p:nvSpPr>
        <p:spPr>
          <a:xfrm>
            <a:off x="10328295" y="1148392"/>
            <a:ext cx="131348" cy="50824"/>
          </a:xfrm>
          <a:prstGeom prst="rect">
            <a:avLst/>
          </a:prstGeom>
          <a:solidFill>
            <a:srgbClr val="2DD4ED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rgbClr val="2DD4ED"/>
              </a:solidFill>
            </a:endParaRP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E0F66EF7-20A3-DD1D-5C9C-75E0B177340F}"/>
              </a:ext>
            </a:extLst>
          </p:cNvPr>
          <p:cNvSpPr txBox="1"/>
          <p:nvPr/>
        </p:nvSpPr>
        <p:spPr>
          <a:xfrm>
            <a:off x="10429175" y="906288"/>
            <a:ext cx="39155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No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A01313A9-A3D5-ED4F-489C-F5B27845D1C0}"/>
              </a:ext>
            </a:extLst>
          </p:cNvPr>
          <p:cNvSpPr txBox="1"/>
          <p:nvPr/>
        </p:nvSpPr>
        <p:spPr>
          <a:xfrm>
            <a:off x="10429174" y="1062722"/>
            <a:ext cx="46706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Yes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026E84D7-D8C1-294B-B96E-EC9BA59B975F}"/>
              </a:ext>
            </a:extLst>
          </p:cNvPr>
          <p:cNvSpPr txBox="1"/>
          <p:nvPr/>
        </p:nvSpPr>
        <p:spPr>
          <a:xfrm rot="16200000">
            <a:off x="123849" y="2354964"/>
            <a:ext cx="39466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H2A</a:t>
            </a:r>
            <a:endParaRPr lang="en-US" dirty="0"/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484C9A3F-DC19-57D5-2AF4-AD21A295C3D3}"/>
              </a:ext>
            </a:extLst>
          </p:cNvPr>
          <p:cNvSpPr txBox="1"/>
          <p:nvPr/>
        </p:nvSpPr>
        <p:spPr>
          <a:xfrm rot="16200000">
            <a:off x="7806199" y="2471328"/>
            <a:ext cx="32733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H3</a:t>
            </a:r>
            <a:endParaRPr lang="en-US" dirty="0"/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81DD1B5B-EA65-E029-A4CF-3BB9EA11A2EA}"/>
              </a:ext>
            </a:extLst>
          </p:cNvPr>
          <p:cNvSpPr txBox="1"/>
          <p:nvPr/>
        </p:nvSpPr>
        <p:spPr>
          <a:xfrm rot="16200000">
            <a:off x="3609076" y="2370840"/>
            <a:ext cx="39626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H2B</a:t>
            </a:r>
            <a:endParaRPr lang="en-US" dirty="0"/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A6CDB233-7425-C57B-4B7F-35DAA8646C40}"/>
              </a:ext>
            </a:extLst>
          </p:cNvPr>
          <p:cNvSpPr txBox="1"/>
          <p:nvPr/>
        </p:nvSpPr>
        <p:spPr>
          <a:xfrm>
            <a:off x="1558030" y="6321082"/>
            <a:ext cx="63510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b="1" dirty="0"/>
              <a:t>AF Status</a:t>
            </a:r>
            <a:endParaRPr lang="en-US" b="1" dirty="0"/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32FD0DEF-5631-B671-CC03-D08FE31D81DD}"/>
              </a:ext>
            </a:extLst>
          </p:cNvPr>
          <p:cNvSpPr txBox="1"/>
          <p:nvPr/>
        </p:nvSpPr>
        <p:spPr>
          <a:xfrm>
            <a:off x="2239612" y="6303125"/>
            <a:ext cx="6543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Persistent</a:t>
            </a:r>
            <a:endParaRPr lang="en-US" dirty="0"/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2776398D-8BE6-CB61-6AA7-7EDDF28073A6}"/>
              </a:ext>
            </a:extLst>
          </p:cNvPr>
          <p:cNvSpPr txBox="1"/>
          <p:nvPr/>
        </p:nvSpPr>
        <p:spPr>
          <a:xfrm>
            <a:off x="781094" y="6310743"/>
            <a:ext cx="53412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Control</a:t>
            </a:r>
            <a:endParaRPr lang="en-US" dirty="0"/>
          </a:p>
        </p:txBody>
      </p:sp>
      <p:sp>
        <p:nvSpPr>
          <p:cNvPr id="52" name="Rectangle 51">
            <a:extLst>
              <a:ext uri="{FF2B5EF4-FFF2-40B4-BE49-F238E27FC236}">
                <a16:creationId xmlns:a16="http://schemas.microsoft.com/office/drawing/2014/main" id="{B6619F08-2587-F57E-0048-242ED734CEBE}"/>
              </a:ext>
            </a:extLst>
          </p:cNvPr>
          <p:cNvSpPr/>
          <p:nvPr/>
        </p:nvSpPr>
        <p:spPr>
          <a:xfrm>
            <a:off x="2676177" y="3932665"/>
            <a:ext cx="131348" cy="50824"/>
          </a:xfrm>
          <a:prstGeom prst="rect">
            <a:avLst/>
          </a:prstGeom>
          <a:solidFill>
            <a:schemeClr val="accent2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3" name="Rectangle 52">
            <a:extLst>
              <a:ext uri="{FF2B5EF4-FFF2-40B4-BE49-F238E27FC236}">
                <a16:creationId xmlns:a16="http://schemas.microsoft.com/office/drawing/2014/main" id="{91F22043-6478-DA7D-E8A1-BDB9D46F6BC7}"/>
              </a:ext>
            </a:extLst>
          </p:cNvPr>
          <p:cNvSpPr/>
          <p:nvPr/>
        </p:nvSpPr>
        <p:spPr>
          <a:xfrm>
            <a:off x="2676177" y="4069159"/>
            <a:ext cx="131348" cy="50824"/>
          </a:xfrm>
          <a:prstGeom prst="rect">
            <a:avLst/>
          </a:prstGeom>
          <a:solidFill>
            <a:srgbClr val="2DD4ED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rgbClr val="2DD4ED"/>
              </a:solidFill>
            </a:endParaRP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30D47FCF-5E26-4760-D35E-EA3E99E48565}"/>
              </a:ext>
            </a:extLst>
          </p:cNvPr>
          <p:cNvSpPr txBox="1"/>
          <p:nvPr/>
        </p:nvSpPr>
        <p:spPr>
          <a:xfrm>
            <a:off x="2777057" y="3827055"/>
            <a:ext cx="39155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No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CFA24A48-0E5B-669C-9101-76554FDC05B4}"/>
              </a:ext>
            </a:extLst>
          </p:cNvPr>
          <p:cNvSpPr txBox="1"/>
          <p:nvPr/>
        </p:nvSpPr>
        <p:spPr>
          <a:xfrm>
            <a:off x="2777056" y="3983489"/>
            <a:ext cx="46706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Yes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5E90DE92-A126-C513-D08E-0956CD8B859B}"/>
              </a:ext>
            </a:extLst>
          </p:cNvPr>
          <p:cNvSpPr txBox="1"/>
          <p:nvPr/>
        </p:nvSpPr>
        <p:spPr>
          <a:xfrm rot="16200000">
            <a:off x="268619" y="5316153"/>
            <a:ext cx="32733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H4</a:t>
            </a:r>
            <a:endParaRPr lang="en-US" dirty="0"/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D2A9809F-F415-E786-73C3-0ADA13B36AAF}"/>
              </a:ext>
            </a:extLst>
          </p:cNvPr>
          <p:cNvSpPr txBox="1"/>
          <p:nvPr/>
        </p:nvSpPr>
        <p:spPr>
          <a:xfrm>
            <a:off x="5222620" y="6329174"/>
            <a:ext cx="63510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b="1" dirty="0"/>
              <a:t>AF Status</a:t>
            </a:r>
            <a:endParaRPr lang="en-US" b="1" dirty="0"/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8C32AB6B-6395-4291-757E-E6E729C3ADF6}"/>
              </a:ext>
            </a:extLst>
          </p:cNvPr>
          <p:cNvSpPr txBox="1"/>
          <p:nvPr/>
        </p:nvSpPr>
        <p:spPr>
          <a:xfrm>
            <a:off x="6046721" y="6331501"/>
            <a:ext cx="6543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Persistent</a:t>
            </a:r>
            <a:endParaRPr lang="en-US" dirty="0"/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40160B64-6493-7461-CD11-5B5E76321B83}"/>
              </a:ext>
            </a:extLst>
          </p:cNvPr>
          <p:cNvSpPr txBox="1"/>
          <p:nvPr/>
        </p:nvSpPr>
        <p:spPr>
          <a:xfrm>
            <a:off x="4422534" y="6316891"/>
            <a:ext cx="53412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Control</a:t>
            </a:r>
            <a:endParaRPr lang="en-US" dirty="0"/>
          </a:p>
        </p:txBody>
      </p:sp>
      <p:sp>
        <p:nvSpPr>
          <p:cNvPr id="72" name="Rectangle 71">
            <a:extLst>
              <a:ext uri="{FF2B5EF4-FFF2-40B4-BE49-F238E27FC236}">
                <a16:creationId xmlns:a16="http://schemas.microsoft.com/office/drawing/2014/main" id="{13A65EBC-BE0A-8D7E-5386-7C045BA1A96C}"/>
              </a:ext>
            </a:extLst>
          </p:cNvPr>
          <p:cNvSpPr/>
          <p:nvPr/>
        </p:nvSpPr>
        <p:spPr>
          <a:xfrm>
            <a:off x="6380204" y="3923088"/>
            <a:ext cx="131348" cy="50824"/>
          </a:xfrm>
          <a:prstGeom prst="rect">
            <a:avLst/>
          </a:prstGeom>
          <a:solidFill>
            <a:schemeClr val="accent2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3" name="Rectangle 72">
            <a:extLst>
              <a:ext uri="{FF2B5EF4-FFF2-40B4-BE49-F238E27FC236}">
                <a16:creationId xmlns:a16="http://schemas.microsoft.com/office/drawing/2014/main" id="{ABEC955D-27CB-4B29-EC1F-4C33FF710C7E}"/>
              </a:ext>
            </a:extLst>
          </p:cNvPr>
          <p:cNvSpPr/>
          <p:nvPr/>
        </p:nvSpPr>
        <p:spPr>
          <a:xfrm>
            <a:off x="6380204" y="4059582"/>
            <a:ext cx="131348" cy="50824"/>
          </a:xfrm>
          <a:prstGeom prst="rect">
            <a:avLst/>
          </a:prstGeom>
          <a:solidFill>
            <a:srgbClr val="2DD4ED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rgbClr val="2DD4ED"/>
              </a:solidFill>
            </a:endParaRP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9FD13103-10BF-37BF-1D32-969D0CB747EB}"/>
              </a:ext>
            </a:extLst>
          </p:cNvPr>
          <p:cNvSpPr txBox="1"/>
          <p:nvPr/>
        </p:nvSpPr>
        <p:spPr>
          <a:xfrm>
            <a:off x="6481084" y="3817478"/>
            <a:ext cx="39155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No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2E6F91EC-7163-4097-95AC-EB72661CAC4E}"/>
              </a:ext>
            </a:extLst>
          </p:cNvPr>
          <p:cNvSpPr txBox="1"/>
          <p:nvPr/>
        </p:nvSpPr>
        <p:spPr>
          <a:xfrm>
            <a:off x="6481083" y="3973912"/>
            <a:ext cx="46706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Yes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2953EE87-E243-8E3C-7473-BEA57B7D83F9}"/>
              </a:ext>
            </a:extLst>
          </p:cNvPr>
          <p:cNvSpPr txBox="1"/>
          <p:nvPr/>
        </p:nvSpPr>
        <p:spPr>
          <a:xfrm rot="16200000">
            <a:off x="3644727" y="5338582"/>
            <a:ext cx="50847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H3/H4</a:t>
            </a:r>
            <a:endParaRPr lang="en-US" dirty="0"/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9C072118-4A00-9DB8-19D3-5B5D32F89729}"/>
              </a:ext>
            </a:extLst>
          </p:cNvPr>
          <p:cNvSpPr txBox="1"/>
          <p:nvPr/>
        </p:nvSpPr>
        <p:spPr>
          <a:xfrm>
            <a:off x="9150732" y="6352230"/>
            <a:ext cx="63510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b="1" dirty="0"/>
              <a:t>AF Status</a:t>
            </a:r>
            <a:endParaRPr lang="en-US" b="1" dirty="0"/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F2A7606C-1F03-EA13-9453-830D1A7971FC}"/>
              </a:ext>
            </a:extLst>
          </p:cNvPr>
          <p:cNvSpPr txBox="1"/>
          <p:nvPr/>
        </p:nvSpPr>
        <p:spPr>
          <a:xfrm>
            <a:off x="9960504" y="6342549"/>
            <a:ext cx="6543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Persistent</a:t>
            </a:r>
            <a:endParaRPr lang="en-US" dirty="0"/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9980FA82-162E-D117-201F-CC92A8C546CC}"/>
              </a:ext>
            </a:extLst>
          </p:cNvPr>
          <p:cNvSpPr txBox="1"/>
          <p:nvPr/>
        </p:nvSpPr>
        <p:spPr>
          <a:xfrm>
            <a:off x="8406558" y="6352230"/>
            <a:ext cx="53412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Control</a:t>
            </a:r>
            <a:endParaRPr lang="en-US" dirty="0"/>
          </a:p>
        </p:txBody>
      </p:sp>
      <p:sp>
        <p:nvSpPr>
          <p:cNvPr id="82" name="Rectangle 81">
            <a:extLst>
              <a:ext uri="{FF2B5EF4-FFF2-40B4-BE49-F238E27FC236}">
                <a16:creationId xmlns:a16="http://schemas.microsoft.com/office/drawing/2014/main" id="{6BC53BCD-16F2-A28F-333F-C721278D4949}"/>
              </a:ext>
            </a:extLst>
          </p:cNvPr>
          <p:cNvSpPr/>
          <p:nvPr/>
        </p:nvSpPr>
        <p:spPr>
          <a:xfrm>
            <a:off x="10328295" y="3929580"/>
            <a:ext cx="131348" cy="50824"/>
          </a:xfrm>
          <a:prstGeom prst="rect">
            <a:avLst/>
          </a:prstGeom>
          <a:solidFill>
            <a:schemeClr val="accent2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3" name="Rectangle 82">
            <a:extLst>
              <a:ext uri="{FF2B5EF4-FFF2-40B4-BE49-F238E27FC236}">
                <a16:creationId xmlns:a16="http://schemas.microsoft.com/office/drawing/2014/main" id="{5CAEA6DA-8721-D604-33FC-0EE3E14B40BA}"/>
              </a:ext>
            </a:extLst>
          </p:cNvPr>
          <p:cNvSpPr/>
          <p:nvPr/>
        </p:nvSpPr>
        <p:spPr>
          <a:xfrm>
            <a:off x="10328295" y="4066074"/>
            <a:ext cx="131348" cy="50824"/>
          </a:xfrm>
          <a:prstGeom prst="rect">
            <a:avLst/>
          </a:prstGeom>
          <a:solidFill>
            <a:srgbClr val="2DD4ED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rgbClr val="2DD4ED"/>
              </a:solidFill>
            </a:endParaRP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41A0EC73-AE9A-4F52-D33C-7CD65104E490}"/>
              </a:ext>
            </a:extLst>
          </p:cNvPr>
          <p:cNvSpPr txBox="1"/>
          <p:nvPr/>
        </p:nvSpPr>
        <p:spPr>
          <a:xfrm>
            <a:off x="10429175" y="3823970"/>
            <a:ext cx="39155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No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6206A14C-D182-C447-F7A0-F464B7B59D66}"/>
              </a:ext>
            </a:extLst>
          </p:cNvPr>
          <p:cNvSpPr txBox="1"/>
          <p:nvPr/>
        </p:nvSpPr>
        <p:spPr>
          <a:xfrm>
            <a:off x="10429174" y="3980404"/>
            <a:ext cx="46706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Yes</a:t>
            </a: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0A57AE92-78DB-8066-B51F-1322DCEBDBB9}"/>
              </a:ext>
            </a:extLst>
          </p:cNvPr>
          <p:cNvSpPr txBox="1"/>
          <p:nvPr/>
        </p:nvSpPr>
        <p:spPr>
          <a:xfrm rot="16200000">
            <a:off x="7527661" y="5443754"/>
            <a:ext cx="77136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MacroH2A1</a:t>
            </a:r>
            <a:endParaRPr lang="en-US" dirty="0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B21F58DF-E22D-9780-80EB-6E0DCD0665CC}"/>
              </a:ext>
            </a:extLst>
          </p:cNvPr>
          <p:cNvSpPr txBox="1"/>
          <p:nvPr/>
        </p:nvSpPr>
        <p:spPr>
          <a:xfrm>
            <a:off x="2592042" y="812316"/>
            <a:ext cx="83708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900" dirty="0"/>
              <a:t>ACE Inhibitor</a:t>
            </a:r>
            <a:endParaRPr lang="en-US" sz="900" dirty="0"/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BC6C4FC2-120A-E1B0-E442-AB777E467A80}"/>
              </a:ext>
            </a:extLst>
          </p:cNvPr>
          <p:cNvSpPr txBox="1"/>
          <p:nvPr/>
        </p:nvSpPr>
        <p:spPr>
          <a:xfrm>
            <a:off x="4731896" y="105465"/>
            <a:ext cx="28220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b="1" dirty="0"/>
              <a:t>Histones vs ACE Inhibitor</a:t>
            </a:r>
          </a:p>
        </p:txBody>
      </p:sp>
      <p:pic>
        <p:nvPicPr>
          <p:cNvPr id="31" name="Content Placeholder 5">
            <a:extLst>
              <a:ext uri="{FF2B5EF4-FFF2-40B4-BE49-F238E27FC236}">
                <a16:creationId xmlns:a16="http://schemas.microsoft.com/office/drawing/2014/main" id="{20FC4199-35EE-79B3-07A4-8D014B626130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12" r="18191" b="6880"/>
          <a:stretch/>
        </p:blipFill>
        <p:spPr>
          <a:xfrm>
            <a:off x="441066" y="1404342"/>
            <a:ext cx="2869036" cy="1964076"/>
          </a:xfrm>
          <a:prstGeom prst="rect">
            <a:avLst/>
          </a:prstGeom>
        </p:spPr>
      </p:pic>
      <p:pic>
        <p:nvPicPr>
          <p:cNvPr id="35" name="Picture 34">
            <a:extLst>
              <a:ext uri="{FF2B5EF4-FFF2-40B4-BE49-F238E27FC236}">
                <a16:creationId xmlns:a16="http://schemas.microsoft.com/office/drawing/2014/main" id="{4B4096A7-F9CA-8273-3EC1-097C074B747C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06" r="18279" b="8299"/>
          <a:stretch/>
        </p:blipFill>
        <p:spPr>
          <a:xfrm>
            <a:off x="3960116" y="1479663"/>
            <a:ext cx="3047172" cy="1862488"/>
          </a:xfrm>
          <a:prstGeom prst="rect">
            <a:avLst/>
          </a:prstGeom>
        </p:spPr>
      </p:pic>
      <p:sp>
        <p:nvSpPr>
          <p:cNvPr id="36" name="TextBox 35">
            <a:extLst>
              <a:ext uri="{FF2B5EF4-FFF2-40B4-BE49-F238E27FC236}">
                <a16:creationId xmlns:a16="http://schemas.microsoft.com/office/drawing/2014/main" id="{AD7D7D26-4C76-F373-A9B6-A9C9A49C0B97}"/>
              </a:ext>
            </a:extLst>
          </p:cNvPr>
          <p:cNvSpPr txBox="1"/>
          <p:nvPr/>
        </p:nvSpPr>
        <p:spPr>
          <a:xfrm>
            <a:off x="6272097" y="769481"/>
            <a:ext cx="83708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900" dirty="0"/>
              <a:t>ACE Inhibitor</a:t>
            </a:r>
            <a:endParaRPr lang="en-US" sz="900" dirty="0"/>
          </a:p>
        </p:txBody>
      </p:sp>
      <p:pic>
        <p:nvPicPr>
          <p:cNvPr id="44" name="Content Placeholder 6">
            <a:extLst>
              <a:ext uri="{FF2B5EF4-FFF2-40B4-BE49-F238E27FC236}">
                <a16:creationId xmlns:a16="http://schemas.microsoft.com/office/drawing/2014/main" id="{20140ED3-1D6D-BD47-D0BE-6457193ED89A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33" r="18190" b="8513"/>
          <a:stretch/>
        </p:blipFill>
        <p:spPr>
          <a:xfrm>
            <a:off x="8125063" y="1365497"/>
            <a:ext cx="2969704" cy="1964076"/>
          </a:xfrm>
          <a:prstGeom prst="rect">
            <a:avLst/>
          </a:prstGeom>
        </p:spPr>
      </p:pic>
      <p:sp>
        <p:nvSpPr>
          <p:cNvPr id="45" name="TextBox 44">
            <a:extLst>
              <a:ext uri="{FF2B5EF4-FFF2-40B4-BE49-F238E27FC236}">
                <a16:creationId xmlns:a16="http://schemas.microsoft.com/office/drawing/2014/main" id="{403BAA24-F49F-AAE4-1750-D7F8C86C069C}"/>
              </a:ext>
            </a:extLst>
          </p:cNvPr>
          <p:cNvSpPr txBox="1"/>
          <p:nvPr/>
        </p:nvSpPr>
        <p:spPr>
          <a:xfrm>
            <a:off x="10203542" y="759288"/>
            <a:ext cx="83708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900" dirty="0"/>
              <a:t>ACE Inhibitor</a:t>
            </a:r>
            <a:endParaRPr lang="en-US" sz="900" dirty="0"/>
          </a:p>
        </p:txBody>
      </p:sp>
      <p:pic>
        <p:nvPicPr>
          <p:cNvPr id="58" name="Content Placeholder 6">
            <a:extLst>
              <a:ext uri="{FF2B5EF4-FFF2-40B4-BE49-F238E27FC236}">
                <a16:creationId xmlns:a16="http://schemas.microsoft.com/office/drawing/2014/main" id="{2137C927-B05C-504D-7D9A-747FBE40739D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27" r="17075" b="8687"/>
          <a:stretch/>
        </p:blipFill>
        <p:spPr>
          <a:xfrm>
            <a:off x="636503" y="4245695"/>
            <a:ext cx="2869036" cy="2038805"/>
          </a:xfrm>
          <a:prstGeom prst="rect">
            <a:avLst/>
          </a:prstGeom>
        </p:spPr>
      </p:pic>
      <p:sp>
        <p:nvSpPr>
          <p:cNvPr id="63" name="TextBox 62">
            <a:extLst>
              <a:ext uri="{FF2B5EF4-FFF2-40B4-BE49-F238E27FC236}">
                <a16:creationId xmlns:a16="http://schemas.microsoft.com/office/drawing/2014/main" id="{10E72504-11A1-4C49-AC18-67178EAD576C}"/>
              </a:ext>
            </a:extLst>
          </p:cNvPr>
          <p:cNvSpPr txBox="1"/>
          <p:nvPr/>
        </p:nvSpPr>
        <p:spPr>
          <a:xfrm>
            <a:off x="2565325" y="3707555"/>
            <a:ext cx="83708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900" dirty="0"/>
              <a:t>ACE Inhibitor</a:t>
            </a:r>
            <a:endParaRPr lang="en-US" sz="900" dirty="0"/>
          </a:p>
        </p:txBody>
      </p:sp>
      <p:pic>
        <p:nvPicPr>
          <p:cNvPr id="64" name="Content Placeholder 6">
            <a:extLst>
              <a:ext uri="{FF2B5EF4-FFF2-40B4-BE49-F238E27FC236}">
                <a16:creationId xmlns:a16="http://schemas.microsoft.com/office/drawing/2014/main" id="{588C897E-7307-3FDB-100F-AEF074C19D12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06" r="18280" b="8687"/>
          <a:stretch/>
        </p:blipFill>
        <p:spPr>
          <a:xfrm>
            <a:off x="4014379" y="4248720"/>
            <a:ext cx="3047173" cy="2038805"/>
          </a:xfrm>
          <a:prstGeom prst="rect">
            <a:avLst/>
          </a:prstGeom>
        </p:spPr>
      </p:pic>
      <p:sp>
        <p:nvSpPr>
          <p:cNvPr id="65" name="TextBox 64">
            <a:extLst>
              <a:ext uri="{FF2B5EF4-FFF2-40B4-BE49-F238E27FC236}">
                <a16:creationId xmlns:a16="http://schemas.microsoft.com/office/drawing/2014/main" id="{3F44B3F4-E38C-9240-D951-CB7B4103871A}"/>
              </a:ext>
            </a:extLst>
          </p:cNvPr>
          <p:cNvSpPr txBox="1"/>
          <p:nvPr/>
        </p:nvSpPr>
        <p:spPr>
          <a:xfrm>
            <a:off x="6265985" y="3686980"/>
            <a:ext cx="83708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900" dirty="0"/>
              <a:t>ACE Inhibitor</a:t>
            </a:r>
            <a:endParaRPr lang="en-US" sz="900" dirty="0"/>
          </a:p>
        </p:txBody>
      </p:sp>
      <p:pic>
        <p:nvPicPr>
          <p:cNvPr id="66" name="Content Placeholder 6">
            <a:extLst>
              <a:ext uri="{FF2B5EF4-FFF2-40B4-BE49-F238E27FC236}">
                <a16:creationId xmlns:a16="http://schemas.microsoft.com/office/drawing/2014/main" id="{02A69790-99C6-2C41-8B2B-E3A5CF11698F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82" r="17803" b="5681"/>
          <a:stretch/>
        </p:blipFill>
        <p:spPr>
          <a:xfrm>
            <a:off x="8080391" y="4259204"/>
            <a:ext cx="3047173" cy="2105916"/>
          </a:xfrm>
          <a:prstGeom prst="rect">
            <a:avLst/>
          </a:prstGeom>
        </p:spPr>
      </p:pic>
      <p:sp>
        <p:nvSpPr>
          <p:cNvPr id="67" name="TextBox 66">
            <a:extLst>
              <a:ext uri="{FF2B5EF4-FFF2-40B4-BE49-F238E27FC236}">
                <a16:creationId xmlns:a16="http://schemas.microsoft.com/office/drawing/2014/main" id="{269FDA51-F91C-D090-22E1-CB87E9515252}"/>
              </a:ext>
            </a:extLst>
          </p:cNvPr>
          <p:cNvSpPr txBox="1"/>
          <p:nvPr/>
        </p:nvSpPr>
        <p:spPr>
          <a:xfrm>
            <a:off x="10236526" y="3673336"/>
            <a:ext cx="83708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900" dirty="0"/>
              <a:t>ACE Inhibitor</a:t>
            </a:r>
            <a:endParaRPr lang="en-US" sz="900" dirty="0"/>
          </a:p>
        </p:txBody>
      </p:sp>
    </p:spTree>
    <p:extLst>
      <p:ext uri="{BB962C8B-B14F-4D97-AF65-F5344CB8AC3E}">
        <p14:creationId xmlns:p14="http://schemas.microsoft.com/office/powerpoint/2010/main" val="1937771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11</TotalTime>
  <Words>68</Words>
  <Application>Microsoft Macintosh PowerPoint</Application>
  <PresentationFormat>Widescreen</PresentationFormat>
  <Paragraphs>4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Calibri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l Figures</dc:title>
  <dc:creator>Vittal, Maanya</dc:creator>
  <cp:lastModifiedBy>Manlio Vinciguera</cp:lastModifiedBy>
  <cp:revision>123</cp:revision>
  <dcterms:created xsi:type="dcterms:W3CDTF">2024-07-31T10:25:22Z</dcterms:created>
  <dcterms:modified xsi:type="dcterms:W3CDTF">2025-11-02T17:51:45Z</dcterms:modified>
</cp:coreProperties>
</file>